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384" r:id="rId2"/>
    <p:sldId id="383" r:id="rId3"/>
  </p:sldIdLst>
  <p:sldSz cx="6858000" cy="9144000" type="screen4x3"/>
  <p:notesSz cx="6742113" cy="98758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7B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4" autoAdjust="0"/>
    <p:restoredTop sz="92709"/>
  </p:normalViewPr>
  <p:slideViewPr>
    <p:cSldViewPr snapToGrid="0" snapToObjects="1">
      <p:cViewPr varScale="1">
        <p:scale>
          <a:sx n="98" d="100"/>
          <a:sy n="98" d="100"/>
        </p:scale>
        <p:origin x="3136" y="2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>
      <p:cViewPr varScale="1">
        <p:scale>
          <a:sx n="142" d="100"/>
          <a:sy n="142" d="100"/>
        </p:scale>
        <p:origin x="1832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/>
              <a:t>Upper first premolar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1'!$I$3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I$4:$I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8.1081081081081088</c:v>
                </c:pt>
                <c:pt idx="4">
                  <c:v>39.189189189189186</c:v>
                </c:pt>
                <c:pt idx="5">
                  <c:v>72.972972972972968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A0C7-4FC0-A717-BAC74BFA6411}"/>
            </c:ext>
          </c:extLst>
        </c:ser>
        <c:ser>
          <c:idx val="1"/>
          <c:order val="1"/>
          <c:tx>
            <c:strRef>
              <c:f>'P1'!$J$3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J$4:$J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7142857142857144</c:v>
                </c:pt>
                <c:pt idx="4">
                  <c:v>34.285714285714285</c:v>
                </c:pt>
                <c:pt idx="5">
                  <c:v>82.857142857142861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A0C7-4FC0-A717-BAC74BFA6411}"/>
            </c:ext>
          </c:extLst>
        </c:ser>
        <c:ser>
          <c:idx val="2"/>
          <c:order val="2"/>
          <c:tx>
            <c:strRef>
              <c:f>'P1'!$K$3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K$4:$K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6.1855670103092786</c:v>
                </c:pt>
                <c:pt idx="8">
                  <c:v>18.556701030927837</c:v>
                </c:pt>
                <c:pt idx="9">
                  <c:v>50.515463917525771</c:v>
                </c:pt>
                <c:pt idx="10">
                  <c:v>92.783505154639172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A0C7-4FC0-A717-BAC74BFA6411}"/>
            </c:ext>
          </c:extLst>
        </c:ser>
        <c:ser>
          <c:idx val="3"/>
          <c:order val="3"/>
          <c:tx>
            <c:strRef>
              <c:f>'P1'!$L$3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L$4:$L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1739130434782608</c:v>
                </c:pt>
                <c:pt idx="7">
                  <c:v>4.3478260869565215</c:v>
                </c:pt>
                <c:pt idx="8">
                  <c:v>30.434782608695656</c:v>
                </c:pt>
                <c:pt idx="9">
                  <c:v>72.826086956521735</c:v>
                </c:pt>
                <c:pt idx="10">
                  <c:v>89.130434782608688</c:v>
                </c:pt>
                <c:pt idx="11">
                  <c:v>97.826086956521735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A0C7-4FC0-A717-BAC74BFA64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10175295"/>
        <c:axId val="733489279"/>
      </c:lineChart>
      <c:catAx>
        <c:axId val="61017529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Age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733489279"/>
        <c:crosses val="autoZero"/>
        <c:auto val="1"/>
        <c:lblAlgn val="ctr"/>
        <c:lblOffset val="100"/>
        <c:tickLblSkip val="2"/>
        <c:noMultiLvlLbl val="0"/>
      </c:catAx>
      <c:valAx>
        <c:axId val="733489279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610175295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/>
              <a:t>Lower first premolar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1'!$M$3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M$4:$M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.75</c:v>
                </c:pt>
                <c:pt idx="4">
                  <c:v>31.25</c:v>
                </c:pt>
                <c:pt idx="5">
                  <c:v>71.25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FFED-4F71-A0D4-360323C4B02D}"/>
            </c:ext>
          </c:extLst>
        </c:ser>
        <c:ser>
          <c:idx val="1"/>
          <c:order val="1"/>
          <c:tx>
            <c:strRef>
              <c:f>'P1'!$N$3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N$4:$N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4.285714285714285</c:v>
                </c:pt>
                <c:pt idx="4">
                  <c:v>55.952380952380956</c:v>
                </c:pt>
                <c:pt idx="5">
                  <c:v>92.857142857142861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FFED-4F71-A0D4-360323C4B02D}"/>
            </c:ext>
          </c:extLst>
        </c:ser>
        <c:ser>
          <c:idx val="2"/>
          <c:order val="2"/>
          <c:tx>
            <c:strRef>
              <c:f>'P1'!$O$3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O$4:$O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.8235294117647065</c:v>
                </c:pt>
                <c:pt idx="9">
                  <c:v>45.098039215686278</c:v>
                </c:pt>
                <c:pt idx="10">
                  <c:v>77.450980392156865</c:v>
                </c:pt>
                <c:pt idx="11">
                  <c:v>95.098039215686271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FFED-4F71-A0D4-360323C4B02D}"/>
            </c:ext>
          </c:extLst>
        </c:ser>
        <c:ser>
          <c:idx val="3"/>
          <c:order val="3"/>
          <c:tx>
            <c:strRef>
              <c:f>'P1'!$P$3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P1'!$H$4:$H$19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1'!$P$4:$P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6.455696202531644</c:v>
                </c:pt>
                <c:pt idx="9">
                  <c:v>53.164556962025308</c:v>
                </c:pt>
                <c:pt idx="10">
                  <c:v>89.87341772151899</c:v>
                </c:pt>
                <c:pt idx="11">
                  <c:v>98.734177215189874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FFED-4F71-A0D4-360323C4B0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10175295"/>
        <c:axId val="733489279"/>
      </c:lineChart>
      <c:catAx>
        <c:axId val="61017529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Age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733489279"/>
        <c:crosses val="autoZero"/>
        <c:auto val="1"/>
        <c:lblAlgn val="ctr"/>
        <c:lblOffset val="100"/>
        <c:tickLblSkip val="2"/>
        <c:noMultiLvlLbl val="0"/>
      </c:catAx>
      <c:valAx>
        <c:axId val="733489279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610175295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/>
              <a:t>Upper second premolar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2'!$I$3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I$5:$I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4285714285714286</c:v>
                </c:pt>
                <c:pt idx="4">
                  <c:v>5.7142857142857144</c:v>
                </c:pt>
                <c:pt idx="5">
                  <c:v>25.714285714285712</c:v>
                </c:pt>
                <c:pt idx="6">
                  <c:v>68.571428571428569</c:v>
                </c:pt>
                <c:pt idx="7">
                  <c:v>95.714285714285722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474B-498E-A764-29CC8B428CA3}"/>
            </c:ext>
          </c:extLst>
        </c:ser>
        <c:ser>
          <c:idx val="1"/>
          <c:order val="1"/>
          <c:tx>
            <c:strRef>
              <c:f>'P2'!$J$3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J$5:$J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5.7142857142857144</c:v>
                </c:pt>
                <c:pt idx="5">
                  <c:v>60</c:v>
                </c:pt>
                <c:pt idx="6">
                  <c:v>91.428571428571431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474B-498E-A764-29CC8B428CA3}"/>
            </c:ext>
          </c:extLst>
        </c:ser>
        <c:ser>
          <c:idx val="2"/>
          <c:order val="2"/>
          <c:tx>
            <c:strRef>
              <c:f>'P2'!$K$3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K$5:$K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1739130434782608</c:v>
                </c:pt>
                <c:pt idx="9">
                  <c:v>26.086956521739129</c:v>
                </c:pt>
                <c:pt idx="10">
                  <c:v>57.608695652173914</c:v>
                </c:pt>
                <c:pt idx="11">
                  <c:v>85.869565217391312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474B-498E-A764-29CC8B428CA3}"/>
            </c:ext>
          </c:extLst>
        </c:ser>
        <c:ser>
          <c:idx val="3"/>
          <c:order val="3"/>
          <c:tx>
            <c:strRef>
              <c:f>'P2'!$L$3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L$5:$L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9.6385542168674707</c:v>
                </c:pt>
                <c:pt idx="9">
                  <c:v>24.096385542168676</c:v>
                </c:pt>
                <c:pt idx="10">
                  <c:v>50.602409638554214</c:v>
                </c:pt>
                <c:pt idx="11">
                  <c:v>77.108433734939766</c:v>
                </c:pt>
                <c:pt idx="12">
                  <c:v>92.771084337349393</c:v>
                </c:pt>
                <c:pt idx="13">
                  <c:v>97.590361445783131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474B-498E-A764-29CC8B428C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43894511"/>
        <c:axId val="831209919"/>
      </c:lineChart>
      <c:catAx>
        <c:axId val="8438945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Age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831209919"/>
        <c:crosses val="autoZero"/>
        <c:auto val="1"/>
        <c:lblAlgn val="ctr"/>
        <c:lblOffset val="100"/>
        <c:tickLblSkip val="2"/>
        <c:noMultiLvlLbl val="0"/>
      </c:catAx>
      <c:valAx>
        <c:axId val="831209919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843894511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/>
              <a:t>Lower second premolar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P2'!$M$3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M$5:$M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4.492753623188406</c:v>
                </c:pt>
                <c:pt idx="5">
                  <c:v>34.782608695652172</c:v>
                </c:pt>
                <c:pt idx="6">
                  <c:v>79.710144927536234</c:v>
                </c:pt>
                <c:pt idx="7">
                  <c:v>97.101449275362313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B36E-4744-8091-3D89149BAC17}"/>
            </c:ext>
          </c:extLst>
        </c:ser>
        <c:ser>
          <c:idx val="1"/>
          <c:order val="1"/>
          <c:tx>
            <c:strRef>
              <c:f>'P2'!$N$3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N$5:$N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6.417910447761194</c:v>
                </c:pt>
                <c:pt idx="5">
                  <c:v>59.701492537313428</c:v>
                </c:pt>
                <c:pt idx="6">
                  <c:v>98.507462686567166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B36E-4744-8091-3D89149BAC17}"/>
            </c:ext>
          </c:extLst>
        </c:ser>
        <c:ser>
          <c:idx val="2"/>
          <c:order val="2"/>
          <c:tx>
            <c:strRef>
              <c:f>'P2'!$O$3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O$5:$O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9801980198019802</c:v>
                </c:pt>
                <c:pt idx="9">
                  <c:v>22.772277227722775</c:v>
                </c:pt>
                <c:pt idx="10">
                  <c:v>50.495049504950494</c:v>
                </c:pt>
                <c:pt idx="11">
                  <c:v>75.247524752475243</c:v>
                </c:pt>
                <c:pt idx="12">
                  <c:v>98.019801980198025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2430-4DE0-8CF8-5AFB8376269B}"/>
            </c:ext>
          </c:extLst>
        </c:ser>
        <c:ser>
          <c:idx val="3"/>
          <c:order val="3"/>
          <c:tx>
            <c:strRef>
              <c:f>'P2'!$P$3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P2'!$H$5:$H$196</c:f>
              <c:numCache>
                <c:formatCode>0</c:formatCode>
                <c:ptCount val="18"/>
                <c:pt idx="0">
                  <c:v>3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P2'!$P$5:$P$19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3.26530612244898</c:v>
                </c:pt>
                <c:pt idx="9">
                  <c:v>26.530612244897959</c:v>
                </c:pt>
                <c:pt idx="10">
                  <c:v>54.081632653061227</c:v>
                </c:pt>
                <c:pt idx="11">
                  <c:v>76.530612244897952</c:v>
                </c:pt>
                <c:pt idx="12">
                  <c:v>97.959183673469383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1-2430-4DE0-8CF8-5AFB837626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43894511"/>
        <c:axId val="831209919"/>
      </c:lineChart>
      <c:catAx>
        <c:axId val="8438945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Age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831209919"/>
        <c:crosses val="autoZero"/>
        <c:auto val="1"/>
        <c:lblAlgn val="ctr"/>
        <c:lblOffset val="100"/>
        <c:tickLblSkip val="2"/>
        <c:noMultiLvlLbl val="0"/>
      </c:catAx>
      <c:valAx>
        <c:axId val="831209919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843894511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25CE4D-0109-7F44-88C6-73800FDA4EC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235075"/>
            <a:ext cx="24971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2747"/>
            <a:ext cx="5393690" cy="38886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AD442C-D07F-3244-8D1A-5AA4A96FE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865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 b="0" i="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09998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03115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45011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2089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 b="0" i="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8401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54801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0" i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0" i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66654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20871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93081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 b="0" i="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 b="0" i="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67791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 b="0" i="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 b="0" i="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95186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84962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b="0" i="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b="0" i="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CE0599D-2217-E64C-B78D-BFCAE7E26A04}"/>
              </a:ext>
            </a:extLst>
          </p:cNvPr>
          <p:cNvSpPr txBox="1"/>
          <p:nvPr/>
        </p:nvSpPr>
        <p:spPr>
          <a:xfrm>
            <a:off x="473529" y="1998617"/>
            <a:ext cx="5910942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ion of dental age based on the developmental stages of permanent teeth in Japanese children and adolescents</a:t>
            </a:r>
          </a:p>
          <a:p>
            <a:pPr algn="just"/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tsuak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uremot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na Okawa*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ay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ayosh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zuma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komot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zuhiko Nakano</a:t>
            </a:r>
          </a:p>
        </p:txBody>
      </p:sp>
    </p:spTree>
    <p:extLst>
      <p:ext uri="{BB962C8B-B14F-4D97-AF65-F5344CB8AC3E}">
        <p14:creationId xmlns:p14="http://schemas.microsoft.com/office/powerpoint/2010/main" val="2924837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3F1745C0-8D02-4F95-9C17-59DD7B86C2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2799529"/>
              </p:ext>
            </p:extLst>
          </p:nvPr>
        </p:nvGraphicFramePr>
        <p:xfrm>
          <a:off x="438231" y="1288488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E772B546-B99A-42BF-A490-2BB990A888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7757012"/>
              </p:ext>
            </p:extLst>
          </p:nvPr>
        </p:nvGraphicFramePr>
        <p:xfrm>
          <a:off x="3429000" y="1288488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2AD7EFC-4150-4D4E-A7CC-A7C212DABA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2184604"/>
              </p:ext>
            </p:extLst>
          </p:nvPr>
        </p:nvGraphicFramePr>
        <p:xfrm>
          <a:off x="438231" y="3447850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31B7E760-12D0-4B95-96B9-BB73426F8B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1517885"/>
              </p:ext>
            </p:extLst>
          </p:nvPr>
        </p:nvGraphicFramePr>
        <p:xfrm>
          <a:off x="3429000" y="3447850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2E38C3A-EA28-48B0-9A8E-199085B4E6FC}"/>
              </a:ext>
            </a:extLst>
          </p:cNvPr>
          <p:cNvSpPr txBox="1"/>
          <p:nvPr/>
        </p:nvSpPr>
        <p:spPr>
          <a:xfrm>
            <a:off x="360486" y="1371168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（</a:t>
            </a:r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%</a:t>
            </a:r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）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2217324-E497-4E5B-A650-80C6C0BEDC78}"/>
              </a:ext>
            </a:extLst>
          </p:cNvPr>
          <p:cNvSpPr txBox="1"/>
          <p:nvPr/>
        </p:nvSpPr>
        <p:spPr>
          <a:xfrm>
            <a:off x="3349871" y="1371168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（</a:t>
            </a:r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%</a:t>
            </a:r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）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53E16E1-7179-42C1-97F3-5E949C341152}"/>
              </a:ext>
            </a:extLst>
          </p:cNvPr>
          <p:cNvSpPr txBox="1"/>
          <p:nvPr/>
        </p:nvSpPr>
        <p:spPr>
          <a:xfrm>
            <a:off x="360486" y="3534253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（</a:t>
            </a:r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%</a:t>
            </a:r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）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5E58C83-D07D-4CCF-A7E4-727FBC92407D}"/>
              </a:ext>
            </a:extLst>
          </p:cNvPr>
          <p:cNvSpPr txBox="1"/>
          <p:nvPr/>
        </p:nvSpPr>
        <p:spPr>
          <a:xfrm>
            <a:off x="3349871" y="3534253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（</a:t>
            </a:r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%</a:t>
            </a:r>
            <a:r>
              <a:rPr lang="ja-JP" altLang="en-US" sz="1015" dirty="0">
                <a:solidFill>
                  <a:schemeClr val="tx1">
                    <a:lumMod val="65000"/>
                    <a:lumOff val="35000"/>
                  </a:schemeClr>
                </a:solidFill>
                <a:ea typeface="+mj-ea"/>
              </a:rPr>
              <a:t>）</a:t>
            </a: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F67C2089-3CAF-43A0-8327-100AB7816E76}"/>
              </a:ext>
            </a:extLst>
          </p:cNvPr>
          <p:cNvSpPr/>
          <p:nvPr/>
        </p:nvSpPr>
        <p:spPr>
          <a:xfrm>
            <a:off x="176348" y="8089747"/>
            <a:ext cx="6505304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frequency distribution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remolars. Th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male upper first premolar showed negative skewness, but the other curves were very close to normal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rown complete;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ot length complete.</a:t>
            </a:r>
          </a:p>
        </p:txBody>
      </p:sp>
    </p:spTree>
    <p:extLst>
      <p:ext uri="{BB962C8B-B14F-4D97-AF65-F5344CB8AC3E}">
        <p14:creationId xmlns:p14="http://schemas.microsoft.com/office/powerpoint/2010/main" val="1330336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Black-Arial">
      <a:majorFont>
        <a:latin typeface="Arial Black" panose="020B0A0402010202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90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90</TotalTime>
  <Words>105</Words>
  <Application>Microsoft Macintosh PowerPoint</Application>
  <PresentationFormat>画面に合わせる (4:3)</PresentationFormat>
  <Paragraphs>1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Arial Black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大川　玲奈</cp:lastModifiedBy>
  <cp:revision>863</cp:revision>
  <cp:lastPrinted>2020-12-21T09:02:59Z</cp:lastPrinted>
  <dcterms:created xsi:type="dcterms:W3CDTF">2019-09-30T01:21:37Z</dcterms:created>
  <dcterms:modified xsi:type="dcterms:W3CDTF">2021-12-20T00:02:10Z</dcterms:modified>
</cp:coreProperties>
</file>